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media/image4.png" ContentType="image/png"/>
  <Override PartName="/ppt/media/image5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C979E-38A4-411B-881F-83BEB2E64B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619D30-2180-45FA-8C3C-8DF8769436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DFFE84-2436-4314-8AB8-316F11BA1D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B8A221-42EE-4BA9-8152-8D9BAC2836F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57039-D70D-464E-A840-937190BB2E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61FB37-7CE5-4041-BEEE-0EB46FD49C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822C63-B8B4-4A9E-B3BD-D235DF7BBA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7AAD6-FF2E-4830-A115-B73BD16FBB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B4A6F-3A19-4256-B9C2-C701AC583C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F64FB-99BF-4A39-9FEE-1519FEA8DA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0E7AD7-1563-47F9-B1A9-CCF441D470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2651F9-7F13-4D55-B031-EBE3F7DBFD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8C7F1C-9145-4949-98B7-C74C75A10F34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image" Target="../media/image4.png"/><Relationship Id="rId8" Type="http://schemas.openxmlformats.org/officeDocument/2006/relationships/package" Target="../embeddings/oleObject4.xlsx"/><Relationship Id="rId9" Type="http://schemas.openxmlformats.org/officeDocument/2006/relationships/image" Target="../media/image5.wmf"/><Relationship Id="rId10" Type="http://schemas.openxmlformats.org/officeDocument/2006/relationships/image" Target="../media/image4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871640" y="3160800"/>
          <a:ext cx="3276720" cy="17082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871640" y="3160800"/>
                    <a:ext cx="3276720" cy="1708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1547640" y="255600"/>
          <a:ext cx="3673800" cy="14940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547640" y="255600"/>
                    <a:ext cx="3673800" cy="1494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1906560" y="1527120"/>
          <a:ext cx="3313080" cy="159228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906560" y="1527120"/>
                    <a:ext cx="331308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7" name=""/>
          <p:cNvSpPr/>
          <p:nvPr/>
        </p:nvSpPr>
        <p:spPr>
          <a:xfrm rot="16200000">
            <a:off x="772560" y="1434240"/>
            <a:ext cx="20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umber of eggs/fema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376360" y="1447920"/>
            <a:ext cx="324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6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095640" y="1447920"/>
            <a:ext cx="360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500720" y="1447920"/>
            <a:ext cx="43164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3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087640" y="162864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087640" y="15228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816360" y="1447920"/>
            <a:ext cx="360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806560" y="3040200"/>
            <a:ext cx="157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ime post-mat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376360" y="2932200"/>
            <a:ext cx="324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6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095640" y="2932200"/>
            <a:ext cx="360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535640" y="293220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3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851280" y="2932200"/>
            <a:ext cx="360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9" name=""/>
          <p:cNvGrpSpPr/>
          <p:nvPr/>
        </p:nvGrpSpPr>
        <p:grpSpPr>
          <a:xfrm>
            <a:off x="4498920" y="260280"/>
            <a:ext cx="649440" cy="345240"/>
            <a:chOff x="4498920" y="260280"/>
            <a:chExt cx="649440" cy="345240"/>
          </a:xfrm>
        </p:grpSpPr>
        <p:sp>
          <p:nvSpPr>
            <p:cNvPr id="60" name=""/>
            <p:cNvSpPr/>
            <p:nvPr/>
          </p:nvSpPr>
          <p:spPr>
            <a:xfrm>
              <a:off x="4498920" y="318960"/>
              <a:ext cx="144720" cy="71640"/>
            </a:xfrm>
            <a:prstGeom prst="rect">
              <a:avLst/>
            </a:prstGeom>
            <a:gradFill rotWithShape="0">
              <a:gsLst>
                <a:gs pos="0">
                  <a:srgbClr val="a7a7a7"/>
                </a:gs>
                <a:gs pos="50000">
                  <a:srgbClr val="ffffff"/>
                </a:gs>
                <a:gs pos="100000">
                  <a:srgbClr val="a7a7a7"/>
                </a:gs>
              </a:gsLst>
              <a:lin ang="10800000"/>
            </a:gra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498920" y="452520"/>
              <a:ext cx="144720" cy="71280"/>
            </a:xfrm>
            <a:prstGeom prst="rect">
              <a:avLst/>
            </a:prstGeom>
            <a:gradFill rotWithShape="0">
              <a:gsLst>
                <a:gs pos="0">
                  <a:srgbClr val="1d1d1d"/>
                </a:gs>
                <a:gs pos="50000">
                  <a:srgbClr val="333333"/>
                </a:gs>
                <a:gs pos="100000">
                  <a:srgbClr val="1d1d1d"/>
                </a:gs>
              </a:gsLst>
              <a:lin ang="10800000"/>
            </a:gra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608720" y="260280"/>
              <a:ext cx="37764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UM</a:t>
              </a:r>
              <a:r>
                <a:rPr b="1" lang="en-US" sz="7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608720" y="390600"/>
              <a:ext cx="53964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Once</a:t>
              </a:r>
              <a:r>
                <a:rPr b="1" lang="en-US" sz="7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4" name=""/>
          <p:cNvGrpSpPr/>
          <p:nvPr/>
        </p:nvGrpSpPr>
        <p:grpSpPr>
          <a:xfrm>
            <a:off x="4498920" y="1665360"/>
            <a:ext cx="936720" cy="484560"/>
            <a:chOff x="4498920" y="1665360"/>
            <a:chExt cx="936720" cy="484560"/>
          </a:xfrm>
        </p:grpSpPr>
        <p:sp>
          <p:nvSpPr>
            <p:cNvPr id="65" name=""/>
            <p:cNvSpPr/>
            <p:nvPr/>
          </p:nvSpPr>
          <p:spPr>
            <a:xfrm>
              <a:off x="4498920" y="1749600"/>
              <a:ext cx="144720" cy="71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498920" y="1873080"/>
              <a:ext cx="144720" cy="71640"/>
            </a:xfrm>
            <a:prstGeom prst="rect">
              <a:avLst/>
            </a:prstGeom>
            <a:gradFill rotWithShape="0">
              <a:gsLst>
                <a:gs pos="0">
                  <a:srgbClr val="585858"/>
                </a:gs>
                <a:gs pos="100000">
                  <a:srgbClr val="c0c0c0"/>
                </a:gs>
              </a:gsLst>
              <a:lin ang="10800000"/>
            </a:gra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498920" y="2000160"/>
              <a:ext cx="144720" cy="71640"/>
            </a:xfrm>
            <a:prstGeom prst="rect">
              <a:avLst/>
            </a:prstGeom>
            <a:blipFill rotWithShape="0">
              <a:blip r:embed="rId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606920" y="1935000"/>
              <a:ext cx="82872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Twice</a:t>
              </a:r>
              <a:r>
                <a:rPr b="1" lang="en-US" sz="700" spc="-1" strike="noStrike" baseline="-25000">
                  <a:solidFill>
                    <a:srgbClr val="000000"/>
                  </a:solidFill>
                  <a:latin typeface="Arial"/>
                </a:rPr>
                <a:t>3&amp;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606920" y="1665360"/>
              <a:ext cx="51264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UM</a:t>
              </a:r>
              <a:r>
                <a:rPr b="1" lang="en-US" sz="7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606920" y="1790640"/>
              <a:ext cx="68436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Once</a:t>
              </a:r>
              <a:r>
                <a:rPr b="1" lang="en-US" sz="7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1" name=""/>
          <p:cNvSpPr/>
          <p:nvPr/>
        </p:nvSpPr>
        <p:spPr>
          <a:xfrm rot="16200000">
            <a:off x="920880" y="3778200"/>
            <a:ext cx="171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rtl="1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umber of eggs/fema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087640" y="4940280"/>
            <a:ext cx="33480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ime post-eclo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240000" y="4784760"/>
            <a:ext cx="324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6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916360" y="4784760"/>
            <a:ext cx="32364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5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600360" y="4784760"/>
            <a:ext cx="324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7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643280" y="4784760"/>
            <a:ext cx="39708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0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995640" y="4784760"/>
            <a:ext cx="324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8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356000" y="4784760"/>
            <a:ext cx="324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9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160720" y="4784760"/>
            <a:ext cx="32364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3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556000" y="4784760"/>
            <a:ext cx="32364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4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498920" y="4202280"/>
            <a:ext cx="828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rtl="1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Unmate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498920" y="4275000"/>
            <a:ext cx="54000" cy="69840"/>
          </a:xfrm>
          <a:prstGeom prst="diamond">
            <a:avLst/>
          </a:prstGeom>
          <a:solidFill>
            <a:srgbClr val="000066"/>
          </a:solidFill>
          <a:ln w="9360">
            <a:solidFill>
              <a:srgbClr val="00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520" bIns="-1152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087640" y="335592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4" name=""/>
          <p:cNvGraphicFramePr/>
          <p:nvPr/>
        </p:nvGraphicFramePr>
        <p:xfrm>
          <a:off x="1330200" y="5110200"/>
          <a:ext cx="3818160" cy="1558800"/>
        </p:xfrm>
        <a:graphic>
          <a:graphicData uri="http://schemas.openxmlformats.org/presentationml/2006/ole">
            <p:oleObj progId="Excel.Sheet.12" r:id="rId8" spid="">
              <p:embed/>
              <p:pic>
                <p:nvPicPr>
                  <p:cNvPr id="85" name="" descr=""/>
                  <p:cNvPicPr/>
                  <p:nvPr/>
                </p:nvPicPr>
                <p:blipFill>
                  <a:blip r:embed="rId9"/>
                  <a:stretch/>
                </p:blipFill>
                <p:spPr>
                  <a:xfrm>
                    <a:off x="1330200" y="5110200"/>
                    <a:ext cx="3818160" cy="1558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6" name=""/>
          <p:cNvSpPr/>
          <p:nvPr/>
        </p:nvSpPr>
        <p:spPr>
          <a:xfrm rot="16200000">
            <a:off x="909720" y="5819760"/>
            <a:ext cx="1741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%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ertility (adults/egg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7" name=""/>
          <p:cNvGrpSpPr/>
          <p:nvPr/>
        </p:nvGrpSpPr>
        <p:grpSpPr>
          <a:xfrm>
            <a:off x="3994200" y="5589720"/>
            <a:ext cx="144360" cy="72720"/>
            <a:chOff x="3994200" y="5589720"/>
            <a:chExt cx="144360" cy="72720"/>
          </a:xfrm>
        </p:grpSpPr>
        <p:sp>
          <p:nvSpPr>
            <p:cNvPr id="88" name=""/>
            <p:cNvSpPr/>
            <p:nvPr/>
          </p:nvSpPr>
          <p:spPr>
            <a:xfrm>
              <a:off x="3994200" y="5589720"/>
              <a:ext cx="1443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4138560" y="5589720"/>
              <a:ext cx="0" cy="72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994200" y="5589720"/>
              <a:ext cx="0" cy="72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1" name=""/>
          <p:cNvSpPr/>
          <p:nvPr/>
        </p:nvSpPr>
        <p:spPr>
          <a:xfrm>
            <a:off x="3921120" y="5423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087640" y="520704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771640" y="6561000"/>
            <a:ext cx="157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ime post-mat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341440" y="6453360"/>
            <a:ext cx="324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6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060720" y="6453360"/>
            <a:ext cx="360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500720" y="645336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3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816360" y="6453360"/>
            <a:ext cx="360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8" name=""/>
          <p:cNvGrpSpPr/>
          <p:nvPr/>
        </p:nvGrpSpPr>
        <p:grpSpPr>
          <a:xfrm>
            <a:off x="4498920" y="5157720"/>
            <a:ext cx="936720" cy="483120"/>
            <a:chOff x="4498920" y="5157720"/>
            <a:chExt cx="936720" cy="483120"/>
          </a:xfrm>
        </p:grpSpPr>
        <p:sp>
          <p:nvSpPr>
            <p:cNvPr id="99" name=""/>
            <p:cNvSpPr/>
            <p:nvPr/>
          </p:nvSpPr>
          <p:spPr>
            <a:xfrm>
              <a:off x="4498920" y="5245200"/>
              <a:ext cx="144720" cy="71280"/>
            </a:xfrm>
            <a:prstGeom prst="rect">
              <a:avLst/>
            </a:prstGeom>
            <a:gradFill rotWithShape="0">
              <a:gsLst>
                <a:gs pos="0">
                  <a:srgbClr val="1d1d1d"/>
                </a:gs>
                <a:gs pos="50000">
                  <a:srgbClr val="333333"/>
                </a:gs>
                <a:gs pos="100000">
                  <a:srgbClr val="1d1d1d"/>
                </a:gs>
              </a:gsLst>
              <a:lin ang="10800000"/>
            </a:gra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498920" y="5372280"/>
              <a:ext cx="144720" cy="71280"/>
            </a:xfrm>
            <a:prstGeom prst="rect">
              <a:avLst/>
            </a:prstGeom>
            <a:gradFill rotWithShape="0">
              <a:gsLst>
                <a:gs pos="0">
                  <a:srgbClr val="585858"/>
                </a:gs>
                <a:gs pos="100000">
                  <a:srgbClr val="c0c0c0"/>
                </a:gs>
              </a:gsLst>
              <a:lin ang="10800000"/>
            </a:gra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498920" y="5499000"/>
              <a:ext cx="144720" cy="71640"/>
            </a:xfrm>
            <a:prstGeom prst="rect">
              <a:avLst/>
            </a:prstGeom>
            <a:blipFill rotWithShape="0">
              <a:blip r:embed="rId10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606920" y="5425920"/>
              <a:ext cx="82872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Twice</a:t>
              </a:r>
              <a:r>
                <a:rPr b="1" lang="en-US" sz="700" spc="-1" strike="noStrike" baseline="-25000">
                  <a:solidFill>
                    <a:srgbClr val="000000"/>
                  </a:solidFill>
                  <a:latin typeface="Arial"/>
                </a:rPr>
                <a:t>3&amp;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606920" y="5157720"/>
              <a:ext cx="53964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Once</a:t>
              </a:r>
              <a:r>
                <a:rPr b="1" lang="en-US" sz="7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4606920" y="5318280"/>
              <a:ext cx="68436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Once</a:t>
              </a:r>
              <a:r>
                <a:rPr b="1" lang="en-US" sz="7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5" name=""/>
          <p:cNvSpPr/>
          <p:nvPr/>
        </p:nvSpPr>
        <p:spPr>
          <a:xfrm>
            <a:off x="6516720" y="130320"/>
            <a:ext cx="255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Kapelnikov et al. additional file 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24T12:21:34Z</dcterms:created>
  <dc:creator>user</dc:creator>
  <dc:description/>
  <dc:language>en-US</dc:language>
  <cp:lastModifiedBy> </cp:lastModifiedBy>
  <dcterms:modified xsi:type="dcterms:W3CDTF">2008-07-23T12:35:39Z</dcterms:modified>
  <cp:revision>38</cp:revision>
  <dc:subject/>
  <dc:title>Slide 1</dc:title>
</cp:coreProperties>
</file>